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90" d="100"/>
          <a:sy n="90" d="100"/>
        </p:scale>
        <p:origin x="-510" y="-4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8A189-8F73-4C7C-AAF7-DF55827C70C8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ACE8F-B8D2-42A8-818E-39B42AA75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96748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8A189-8F73-4C7C-AAF7-DF55827C70C8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ACE8F-B8D2-42A8-818E-39B42AA75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07328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8A189-8F73-4C7C-AAF7-DF55827C70C8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ACE8F-B8D2-42A8-818E-39B42AA75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89556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8A189-8F73-4C7C-AAF7-DF55827C70C8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ACE8F-B8D2-42A8-818E-39B42AA75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42911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8A189-8F73-4C7C-AAF7-DF55827C70C8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ACE8F-B8D2-42A8-818E-39B42AA75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77161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8A189-8F73-4C7C-AAF7-DF55827C70C8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ACE8F-B8D2-42A8-818E-39B42AA75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77310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8A189-8F73-4C7C-AAF7-DF55827C70C8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ACE8F-B8D2-42A8-818E-39B42AA75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74451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8A189-8F73-4C7C-AAF7-DF55827C70C8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ACE8F-B8D2-42A8-818E-39B42AA75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28118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8A189-8F73-4C7C-AAF7-DF55827C70C8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ACE8F-B8D2-42A8-818E-39B42AA75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39966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8A189-8F73-4C7C-AAF7-DF55827C70C8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ACE8F-B8D2-42A8-818E-39B42AA75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47382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8A189-8F73-4C7C-AAF7-DF55827C70C8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ACE8F-B8D2-42A8-818E-39B42AA75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64356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C8A189-8F73-4C7C-AAF7-DF55827C70C8}" type="datetimeFigureOut">
              <a:rPr lang="en-US" smtClean="0"/>
              <a:t>11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6ACE8F-B8D2-42A8-818E-39B42AA75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97478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779172"/>
              </p:ext>
            </p:extLst>
          </p:nvPr>
        </p:nvGraphicFramePr>
        <p:xfrm>
          <a:off x="3443954" y="2935375"/>
          <a:ext cx="4216402" cy="83945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96502"/>
                <a:gridCol w="654975"/>
                <a:gridCol w="654975"/>
                <a:gridCol w="654975"/>
                <a:gridCol w="654975"/>
              </a:tblGrid>
              <a:tr h="19522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C64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MS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ra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a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mb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522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otal # of Cells Counted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6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3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0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2450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# Cl. Parp</a:t>
                      </a:r>
                      <a:r>
                        <a:rPr lang="en-US" sz="1100" u="none" strike="noStrike" baseline="30000">
                          <a:effectLst/>
                        </a:rPr>
                        <a:t>+</a:t>
                      </a:r>
                      <a:r>
                        <a:rPr lang="en-US" sz="1100" u="none" strike="noStrike">
                          <a:effectLst/>
                        </a:rPr>
                        <a:t> p-S6</a:t>
                      </a:r>
                      <a:r>
                        <a:rPr lang="en-US" sz="1100" u="none" strike="noStrike" baseline="30000">
                          <a:effectLst/>
                        </a:rPr>
                        <a:t>high</a:t>
                      </a:r>
                      <a:r>
                        <a:rPr lang="en-US" sz="1100" u="none" strike="noStrike">
                          <a:effectLst/>
                        </a:rPr>
                        <a:t> cell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2450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# Cl. </a:t>
                      </a:r>
                      <a:r>
                        <a:rPr lang="en-US" sz="1100" u="none" strike="noStrike" dirty="0" err="1">
                          <a:effectLst/>
                        </a:rPr>
                        <a:t>Parp</a:t>
                      </a:r>
                      <a:r>
                        <a:rPr lang="en-US" sz="1100" u="none" strike="noStrike" baseline="30000" dirty="0">
                          <a:effectLst/>
                        </a:rPr>
                        <a:t>+</a:t>
                      </a:r>
                      <a:r>
                        <a:rPr lang="en-US" sz="1100" u="none" strike="noStrike" dirty="0">
                          <a:effectLst/>
                        </a:rPr>
                        <a:t> p-S6</a:t>
                      </a:r>
                      <a:r>
                        <a:rPr lang="en-US" sz="1100" u="none" strike="noStrike" baseline="30000" dirty="0">
                          <a:effectLst/>
                        </a:rPr>
                        <a:t>low</a:t>
                      </a:r>
                      <a:r>
                        <a:rPr lang="en-US" sz="1100" u="none" strike="noStrike" dirty="0">
                          <a:effectLst/>
                        </a:rPr>
                        <a:t> cell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3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03327029"/>
              </p:ext>
            </p:extLst>
          </p:nvPr>
        </p:nvGraphicFramePr>
        <p:xfrm>
          <a:off x="3443954" y="1925725"/>
          <a:ext cx="4216400" cy="10096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32492"/>
                <a:gridCol w="685800"/>
                <a:gridCol w="615462"/>
                <a:gridCol w="615461"/>
                <a:gridCol w="767185"/>
              </a:tblGrid>
              <a:tr h="190500">
                <a:tc gridSpan="5"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</a:t>
                      </a:r>
                      <a:r>
                        <a:rPr lang="en-US" sz="11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ell counts  (combined from 3 independent experiments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8505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MS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ra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a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Combo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otal # of Cells Counted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67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64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39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106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190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# Cl. Parp</a:t>
                      </a:r>
                      <a:r>
                        <a:rPr lang="en-US" sz="1100" u="none" strike="noStrike" baseline="30000">
                          <a:effectLst/>
                        </a:rPr>
                        <a:t>+</a:t>
                      </a:r>
                      <a:r>
                        <a:rPr lang="en-US" sz="1100" u="none" strike="noStrike">
                          <a:effectLst/>
                        </a:rPr>
                        <a:t> p-S6</a:t>
                      </a:r>
                      <a:r>
                        <a:rPr lang="en-US" sz="1100" u="none" strike="noStrike" baseline="30000">
                          <a:effectLst/>
                        </a:rPr>
                        <a:t>high</a:t>
                      </a:r>
                      <a:r>
                        <a:rPr lang="en-US" sz="1100" u="none" strike="noStrike">
                          <a:effectLst/>
                        </a:rPr>
                        <a:t> cell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190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# Cl. Parp</a:t>
                      </a:r>
                      <a:r>
                        <a:rPr lang="en-US" sz="1100" u="none" strike="noStrike" baseline="30000">
                          <a:effectLst/>
                        </a:rPr>
                        <a:t>+</a:t>
                      </a:r>
                      <a:r>
                        <a:rPr lang="en-US" sz="1100" u="none" strike="noStrike">
                          <a:effectLst/>
                        </a:rPr>
                        <a:t> p-S6</a:t>
                      </a:r>
                      <a:r>
                        <a:rPr lang="en-US" sz="1100" u="none" strike="noStrike" baseline="30000">
                          <a:effectLst/>
                        </a:rPr>
                        <a:t>low</a:t>
                      </a:r>
                      <a:r>
                        <a:rPr lang="en-US" sz="1100" u="none" strike="noStrike">
                          <a:effectLst/>
                        </a:rPr>
                        <a:t> cell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18693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2</Words>
  <Application>Microsoft Office PowerPoint</Application>
  <PresentationFormat>Widescreen</PresentationFormat>
  <Paragraphs>4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adnell, Thomas</dc:creator>
  <cp:lastModifiedBy>Beadnell, Thomas</cp:lastModifiedBy>
  <cp:revision>1</cp:revision>
  <dcterms:created xsi:type="dcterms:W3CDTF">2017-11-05T14:34:42Z</dcterms:created>
  <dcterms:modified xsi:type="dcterms:W3CDTF">2017-11-05T14:35:04Z</dcterms:modified>
</cp:coreProperties>
</file>